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0" d="100"/>
          <a:sy n="130" d="100"/>
        </p:scale>
        <p:origin x="-17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8608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1995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3179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145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0646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7877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7818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565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0847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1835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C34DD-62B7-45B0-BE2E-2B5851400957}" type="datetimeFigureOut">
              <a:rPr lang="ko-KR" altLang="en-US" smtClean="0"/>
              <a:t>2022-12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F319C9-901E-4370-B2C8-29FD3A089F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7351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496" y="55661"/>
            <a:ext cx="10621670" cy="4616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curves for comparison of AMI patients according </a:t>
            </a: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o the presence of dementia and MPR of standard medications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265" y="653181"/>
            <a:ext cx="2694666" cy="2700762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9832" y="650132"/>
            <a:ext cx="2697714" cy="2703811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81790" y="653181"/>
            <a:ext cx="2694666" cy="2703811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0331" y="3381350"/>
            <a:ext cx="2694666" cy="2700762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31409" y="3381350"/>
            <a:ext cx="2697714" cy="2700762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5496" y="6281014"/>
            <a:ext cx="10621670" cy="47118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Note: AMI = acute myocardial infarction, MPR = medication possession ratio, CCB = calcium channel blocker, </a:t>
            </a:r>
          </a:p>
          <a:p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CE = angiotensin converting enzyme inhibitors, ARB = angiotensin receptor blockers, P2Y12 = P2Y</a:t>
            </a:r>
            <a:r>
              <a:rPr lang="en-US" altLang="ko-K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inhibitors.</a:t>
            </a:r>
            <a:endParaRPr lang="ko-K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9411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9</Words>
  <Application>Microsoft Office PowerPoint</Application>
  <PresentationFormat>화면 슬라이드 쇼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ONJAE LEE</dc:creator>
  <cp:lastModifiedBy>WONJAE LEE</cp:lastModifiedBy>
  <cp:revision>2</cp:revision>
  <dcterms:created xsi:type="dcterms:W3CDTF">2021-12-28T05:47:57Z</dcterms:created>
  <dcterms:modified xsi:type="dcterms:W3CDTF">2022-12-01T00:48:05Z</dcterms:modified>
</cp:coreProperties>
</file>